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  <p:sldId id="257" r:id="rId6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7" roundtripDataSignature="AMtx7mgR+ur+UP5yCg0rVhSuqI4mehHVG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7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9" name="Google Shape;89;p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 blanco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3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vertical y text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4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de título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5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5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objetos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6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6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cabezado de sección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7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7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os objetos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8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8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8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ció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9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9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9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9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9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el título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0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ido con título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1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1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n con título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2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3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643467" y="381000"/>
            <a:ext cx="10202333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9. RHS and DGF-1 phylogenetic tree. Internal or Subtelomeric location was indicated.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85" name="Google Shape;85;p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370113" y="990600"/>
            <a:ext cx="10058400" cy="5680131"/>
          </a:xfrm>
          <a:prstGeom prst="rect">
            <a:avLst/>
          </a:prstGeom>
          <a:noFill/>
          <a:ln>
            <a:noFill/>
          </a:ln>
        </p:spPr>
      </p:pic>
      <p:sp>
        <p:nvSpPr>
          <p:cNvPr id="86" name="Google Shape;86;p1"/>
          <p:cNvSpPr txBox="1"/>
          <p:nvPr/>
        </p:nvSpPr>
        <p:spPr>
          <a:xfrm>
            <a:off x="2184400" y="3361267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. DGF-1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0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Google Shape;91;p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873005" y="347133"/>
            <a:ext cx="10058400" cy="6426442"/>
          </a:xfrm>
          <a:prstGeom prst="rect">
            <a:avLst/>
          </a:prstGeom>
          <a:noFill/>
          <a:ln>
            <a:noFill/>
          </a:ln>
        </p:spPr>
      </p:pic>
      <p:sp>
        <p:nvSpPr>
          <p:cNvPr id="92" name="Google Shape;92;p2"/>
          <p:cNvSpPr txBox="1"/>
          <p:nvPr/>
        </p:nvSpPr>
        <p:spPr>
          <a:xfrm>
            <a:off x="1710267" y="3560354"/>
            <a:ext cx="2040467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. RHS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6-13T17:35:43Z</dcterms:created>
  <dc:creator>Gonzalo Greif</dc:creator>
</cp:coreProperties>
</file>